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99" autoAdjust="0"/>
    <p:restoredTop sz="94660"/>
  </p:normalViewPr>
  <p:slideViewPr>
    <p:cSldViewPr snapToGrid="0">
      <p:cViewPr varScale="1">
        <p:scale>
          <a:sx n="84" d="100"/>
          <a:sy n="84" d="100"/>
        </p:scale>
        <p:origin x="3330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378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052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844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63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435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359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428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150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479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969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900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DECE5-E52F-4330-8A8C-EB84EB1EF908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D188B-AFC3-40C9-985F-F3D72829C8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291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411313" y="7365786"/>
            <a:ext cx="6204170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mples of validation of cotton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NPs by allele-specific PCR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uffix of each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L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name indicates the position of the SNP in its sequence. The genomic DNA of cotton TAM 94L-25 (1), NMSI 1331 (2), 15QQ-15 (3) and 15QQ-29 (4) were used as templates, amplified by PCR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a forward allelic primer with or without a sequence tag and reverse primer, and fractionated on 2% agarose gels. F-tag, forward allelic primers with a 21-nucleotide tag; F, forward allelic primer with no tag; R, reverse primer. Sequence analysis showed that the SNPs in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L472-357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L048-413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L044-13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in heterozygous states in </a:t>
            </a:r>
            <a:r>
              <a:rPr lang="pl-PL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M 94L-25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pl-PL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MSI 133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hereas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QQ-15 and 15QQ-29 were F</a:t>
            </a:r>
            <a:r>
              <a:rPr lang="en-US" sz="1100" baseline="-25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hybrids derived from </a:t>
            </a:r>
            <a:r>
              <a:rPr lang="en-US" sz="11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. </a:t>
            </a:r>
            <a:r>
              <a:rPr lang="en-US" sz="11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rsutum</a:t>
            </a:r>
            <a:r>
              <a:rPr lang="en-US" sz="11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 </a:t>
            </a:r>
            <a:r>
              <a:rPr lang="en-US" sz="11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 </a:t>
            </a:r>
            <a:r>
              <a:rPr lang="en-US" sz="11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rbadense</a:t>
            </a:r>
            <a:r>
              <a:rPr lang="en-US" sz="11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osse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3P-54//11K-13/Del Cerro and 13P-54//11K-13/NMSI 1331, respectively. 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523999" y="200159"/>
            <a:ext cx="4023509" cy="4091425"/>
            <a:chOff x="1116436" y="912043"/>
            <a:chExt cx="4293764" cy="4386037"/>
          </a:xfrm>
        </p:grpSpPr>
        <p:grpSp>
          <p:nvGrpSpPr>
            <p:cNvPr id="19" name="Group 18"/>
            <p:cNvGrpSpPr/>
            <p:nvPr/>
          </p:nvGrpSpPr>
          <p:grpSpPr>
            <a:xfrm>
              <a:off x="1638066" y="912043"/>
              <a:ext cx="3772134" cy="4345758"/>
              <a:chOff x="1638066" y="912043"/>
              <a:chExt cx="3772134" cy="4345758"/>
            </a:xfrm>
          </p:grpSpPr>
          <p:grpSp>
            <p:nvGrpSpPr>
              <p:cNvPr id="12" name="Group 11"/>
              <p:cNvGrpSpPr/>
              <p:nvPr/>
            </p:nvGrpSpPr>
            <p:grpSpPr>
              <a:xfrm>
                <a:off x="1638066" y="912043"/>
                <a:ext cx="3772134" cy="4345758"/>
                <a:chOff x="2807318" y="970792"/>
                <a:chExt cx="3952875" cy="4377347"/>
              </a:xfrm>
            </p:grpSpPr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2807318" y="970792"/>
                  <a:ext cx="3952875" cy="1496483"/>
                </a:xfrm>
                <a:prstGeom prst="rect">
                  <a:avLst/>
                </a:prstGeom>
              </p:spPr>
            </p:pic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4245593" y="2502770"/>
                  <a:ext cx="2514600" cy="1409700"/>
                </a:xfrm>
                <a:prstGeom prst="rect">
                  <a:avLst/>
                </a:prstGeom>
              </p:spPr>
            </p:pic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4236068" y="3947964"/>
                  <a:ext cx="2524125" cy="1400175"/>
                </a:xfrm>
                <a:prstGeom prst="rect">
                  <a:avLst/>
                </a:prstGeom>
              </p:spPr>
            </p:pic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807418" y="2502771"/>
                  <a:ext cx="1438275" cy="1409700"/>
                </a:xfrm>
                <a:prstGeom prst="rect">
                  <a:avLst/>
                </a:prstGeom>
              </p:spPr>
            </p:pic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2807318" y="3947964"/>
                  <a:ext cx="1428750" cy="1400175"/>
                </a:xfrm>
                <a:prstGeom prst="rect">
                  <a:avLst/>
                </a:prstGeom>
              </p:spPr>
            </p:pic>
          </p:grpSp>
          <p:sp>
            <p:nvSpPr>
              <p:cNvPr id="13" name="TextBox 12"/>
              <p:cNvSpPr txBox="1"/>
              <p:nvPr/>
            </p:nvSpPr>
            <p:spPr>
              <a:xfrm>
                <a:off x="4565416" y="913128"/>
                <a:ext cx="8386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L472-357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155242" y="941347"/>
                <a:ext cx="8386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L461-215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4549176" y="2411065"/>
                <a:ext cx="8386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L048-413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554927" y="3906510"/>
                <a:ext cx="8386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L044-131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163931" y="2444192"/>
                <a:ext cx="8386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L023-707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180406" y="3906511"/>
                <a:ext cx="8386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L108-330</a:t>
                </a:r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1855137" y="1485692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-tag+R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426952" y="1466642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-tag+R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391026" y="2818894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-tag+R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466983" y="4283582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-tag+R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865497" y="2834288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-tag+R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855136" y="4304291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-tag+R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646225" y="1485692"/>
              <a:ext cx="3802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+R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646225" y="2782239"/>
              <a:ext cx="3802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+R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646225" y="4288336"/>
              <a:ext cx="3802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+R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512610" y="4316544"/>
              <a:ext cx="3802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+R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617385" y="2846541"/>
              <a:ext cx="3802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+R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583098" y="1508291"/>
              <a:ext cx="3802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+R</a:t>
              </a:r>
            </a:p>
          </p:txBody>
        </p:sp>
        <p:grpSp>
          <p:nvGrpSpPr>
            <p:cNvPr id="42" name="Group 41"/>
            <p:cNvGrpSpPr/>
            <p:nvPr/>
          </p:nvGrpSpPr>
          <p:grpSpPr>
            <a:xfrm>
              <a:off x="3249885" y="2192584"/>
              <a:ext cx="470974" cy="215444"/>
              <a:chOff x="3249885" y="2183059"/>
              <a:chExt cx="470974" cy="215444"/>
            </a:xfrm>
          </p:grpSpPr>
          <p:sp>
            <p:nvSpPr>
              <p:cNvPr id="33" name="TextBox 32"/>
              <p:cNvSpPr txBox="1"/>
              <p:nvPr/>
            </p:nvSpPr>
            <p:spPr>
              <a:xfrm>
                <a:off x="3249885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478485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</p:grpSp>
        <p:grpSp>
          <p:nvGrpSpPr>
            <p:cNvPr id="41" name="Group 40"/>
            <p:cNvGrpSpPr/>
            <p:nvPr/>
          </p:nvGrpSpPr>
          <p:grpSpPr>
            <a:xfrm>
              <a:off x="3754710" y="2192584"/>
              <a:ext cx="470974" cy="215444"/>
              <a:chOff x="3754710" y="2183059"/>
              <a:chExt cx="470974" cy="215444"/>
            </a:xfrm>
          </p:grpSpPr>
          <p:sp>
            <p:nvSpPr>
              <p:cNvPr id="35" name="TextBox 34"/>
              <p:cNvSpPr txBox="1"/>
              <p:nvPr/>
            </p:nvSpPr>
            <p:spPr>
              <a:xfrm>
                <a:off x="37547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9833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43" name="Group 42"/>
            <p:cNvGrpSpPr/>
            <p:nvPr/>
          </p:nvGrpSpPr>
          <p:grpSpPr>
            <a:xfrm>
              <a:off x="4293978" y="2183059"/>
              <a:ext cx="1030497" cy="215444"/>
              <a:chOff x="4293978" y="2183059"/>
              <a:chExt cx="1030497" cy="215444"/>
            </a:xfrm>
          </p:grpSpPr>
          <p:sp>
            <p:nvSpPr>
              <p:cNvPr id="37" name="TextBox 36"/>
              <p:cNvSpPr txBox="1"/>
              <p:nvPr/>
            </p:nvSpPr>
            <p:spPr>
              <a:xfrm>
                <a:off x="429397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454162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482737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5065503" y="2183059"/>
                <a:ext cx="25897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44" name="Group 43"/>
            <p:cNvGrpSpPr/>
            <p:nvPr/>
          </p:nvGrpSpPr>
          <p:grpSpPr>
            <a:xfrm>
              <a:off x="1913343" y="2193096"/>
              <a:ext cx="470974" cy="215444"/>
              <a:chOff x="3754710" y="2183059"/>
              <a:chExt cx="470974" cy="215444"/>
            </a:xfrm>
          </p:grpSpPr>
          <p:sp>
            <p:nvSpPr>
              <p:cNvPr id="45" name="TextBox 44"/>
              <p:cNvSpPr txBox="1"/>
              <p:nvPr/>
            </p:nvSpPr>
            <p:spPr>
              <a:xfrm>
                <a:off x="37547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9833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47" name="Group 46"/>
            <p:cNvGrpSpPr/>
            <p:nvPr/>
          </p:nvGrpSpPr>
          <p:grpSpPr>
            <a:xfrm>
              <a:off x="2453826" y="2193095"/>
              <a:ext cx="470974" cy="215444"/>
              <a:chOff x="3754710" y="2183059"/>
              <a:chExt cx="470974" cy="215444"/>
            </a:xfrm>
          </p:grpSpPr>
          <p:sp>
            <p:nvSpPr>
              <p:cNvPr id="48" name="TextBox 47"/>
              <p:cNvSpPr txBox="1"/>
              <p:nvPr/>
            </p:nvSpPr>
            <p:spPr>
              <a:xfrm>
                <a:off x="37547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39833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3239461" y="3596235"/>
              <a:ext cx="1030497" cy="215444"/>
              <a:chOff x="4293978" y="2183059"/>
              <a:chExt cx="1030497" cy="215444"/>
            </a:xfrm>
          </p:grpSpPr>
          <p:sp>
            <p:nvSpPr>
              <p:cNvPr id="51" name="TextBox 50"/>
              <p:cNvSpPr txBox="1"/>
              <p:nvPr/>
            </p:nvSpPr>
            <p:spPr>
              <a:xfrm>
                <a:off x="429397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454162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482737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5065503" y="2183059"/>
                <a:ext cx="25897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4347533" y="3578595"/>
              <a:ext cx="1030497" cy="215444"/>
              <a:chOff x="4293978" y="2183059"/>
              <a:chExt cx="1030497" cy="215444"/>
            </a:xfrm>
          </p:grpSpPr>
          <p:sp>
            <p:nvSpPr>
              <p:cNvPr id="56" name="TextBox 55"/>
              <p:cNvSpPr txBox="1"/>
              <p:nvPr/>
            </p:nvSpPr>
            <p:spPr>
              <a:xfrm>
                <a:off x="429397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454162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482737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5065503" y="2183059"/>
                <a:ext cx="25897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60" name="Group 59"/>
            <p:cNvGrpSpPr/>
            <p:nvPr/>
          </p:nvGrpSpPr>
          <p:grpSpPr>
            <a:xfrm>
              <a:off x="3271631" y="5082636"/>
              <a:ext cx="1030497" cy="215444"/>
              <a:chOff x="4293978" y="2183059"/>
              <a:chExt cx="1030497" cy="215444"/>
            </a:xfrm>
          </p:grpSpPr>
          <p:sp>
            <p:nvSpPr>
              <p:cNvPr id="61" name="TextBox 60"/>
              <p:cNvSpPr txBox="1"/>
              <p:nvPr/>
            </p:nvSpPr>
            <p:spPr>
              <a:xfrm>
                <a:off x="429397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454162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482737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5065503" y="2183059"/>
                <a:ext cx="25897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65" name="Group 64"/>
            <p:cNvGrpSpPr/>
            <p:nvPr/>
          </p:nvGrpSpPr>
          <p:grpSpPr>
            <a:xfrm>
              <a:off x="4379703" y="5064996"/>
              <a:ext cx="1030497" cy="215444"/>
              <a:chOff x="4293978" y="2183059"/>
              <a:chExt cx="1030497" cy="215444"/>
            </a:xfrm>
          </p:grpSpPr>
          <p:sp>
            <p:nvSpPr>
              <p:cNvPr id="66" name="TextBox 65"/>
              <p:cNvSpPr txBox="1"/>
              <p:nvPr/>
            </p:nvSpPr>
            <p:spPr>
              <a:xfrm>
                <a:off x="429397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454162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4827378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5065503" y="2183059"/>
                <a:ext cx="25897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70" name="Group 69"/>
            <p:cNvGrpSpPr/>
            <p:nvPr/>
          </p:nvGrpSpPr>
          <p:grpSpPr>
            <a:xfrm>
              <a:off x="1958102" y="3606959"/>
              <a:ext cx="470974" cy="215444"/>
              <a:chOff x="3754710" y="2183059"/>
              <a:chExt cx="470974" cy="215444"/>
            </a:xfrm>
          </p:grpSpPr>
          <p:sp>
            <p:nvSpPr>
              <p:cNvPr id="71" name="TextBox 70"/>
              <p:cNvSpPr txBox="1"/>
              <p:nvPr/>
            </p:nvSpPr>
            <p:spPr>
              <a:xfrm>
                <a:off x="37547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39833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73" name="Group 72"/>
            <p:cNvGrpSpPr/>
            <p:nvPr/>
          </p:nvGrpSpPr>
          <p:grpSpPr>
            <a:xfrm>
              <a:off x="2498585" y="3606958"/>
              <a:ext cx="470974" cy="215444"/>
              <a:chOff x="3754710" y="2183059"/>
              <a:chExt cx="470974" cy="215444"/>
            </a:xfrm>
          </p:grpSpPr>
          <p:sp>
            <p:nvSpPr>
              <p:cNvPr id="74" name="TextBox 73"/>
              <p:cNvSpPr txBox="1"/>
              <p:nvPr/>
            </p:nvSpPr>
            <p:spPr>
              <a:xfrm>
                <a:off x="37547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39833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76" name="Group 75"/>
            <p:cNvGrpSpPr/>
            <p:nvPr/>
          </p:nvGrpSpPr>
          <p:grpSpPr>
            <a:xfrm>
              <a:off x="1950485" y="5058922"/>
              <a:ext cx="470974" cy="215444"/>
              <a:chOff x="3754710" y="2183059"/>
              <a:chExt cx="470974" cy="215444"/>
            </a:xfrm>
          </p:grpSpPr>
          <p:sp>
            <p:nvSpPr>
              <p:cNvPr id="77" name="TextBox 76"/>
              <p:cNvSpPr txBox="1"/>
              <p:nvPr/>
            </p:nvSpPr>
            <p:spPr>
              <a:xfrm>
                <a:off x="37547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39833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grpSp>
          <p:nvGrpSpPr>
            <p:cNvPr id="79" name="Group 78"/>
            <p:cNvGrpSpPr/>
            <p:nvPr/>
          </p:nvGrpSpPr>
          <p:grpSpPr>
            <a:xfrm>
              <a:off x="2490968" y="5058921"/>
              <a:ext cx="470974" cy="215444"/>
              <a:chOff x="3754710" y="2183059"/>
              <a:chExt cx="470974" cy="215444"/>
            </a:xfrm>
          </p:grpSpPr>
          <p:sp>
            <p:nvSpPr>
              <p:cNvPr id="80" name="TextBox 79"/>
              <p:cNvSpPr txBox="1"/>
              <p:nvPr/>
            </p:nvSpPr>
            <p:spPr>
              <a:xfrm>
                <a:off x="37547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3983310" y="218305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sp>
          <p:nvSpPr>
            <p:cNvPr id="82" name="TextBox 81"/>
            <p:cNvSpPr txBox="1"/>
            <p:nvPr/>
          </p:nvSpPr>
          <p:spPr>
            <a:xfrm>
              <a:off x="1196666" y="2197971"/>
              <a:ext cx="5068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132476" y="2030804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1134961" y="1882687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1127921" y="1734570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186161" y="3617049"/>
              <a:ext cx="5068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121971" y="3468932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1124456" y="3330340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1117416" y="3201273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1185181" y="5055177"/>
              <a:ext cx="5068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1120991" y="4916585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123476" y="4797043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116436" y="4677501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</p:txBody>
        </p:sp>
      </p:grp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3187730"/>
              </p:ext>
            </p:extLst>
          </p:nvPr>
        </p:nvGraphicFramePr>
        <p:xfrm>
          <a:off x="1286106" y="4365199"/>
          <a:ext cx="4902541" cy="2910517"/>
        </p:xfrm>
        <a:graphic>
          <a:graphicData uri="http://schemas.openxmlformats.org/drawingml/2006/table">
            <a:tbl>
              <a:tblPr/>
              <a:tblGrid>
                <a:gridCol w="8188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81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65548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L461-2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-t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GTGACCAAGTTCATGCTCAGGCACTTGTCAATCAAGTT</a:t>
                      </a:r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444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GCACTTGTCAATCAAGTT</a:t>
                      </a:r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3784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TCATTCAGAGAAGATGT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L108-3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-t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GTGACCAAGTTCATGCTCACTGGACAAATCCTGGCACGT</a:t>
                      </a:r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3982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TGGACAAATCCTGGCACGT</a:t>
                      </a:r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1920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GTTCATAGCTATGTCTAGC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L472-3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-t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GTGACCAAGTTCATGCTGTTAAAGAATTTGCTGCAAAGA</a:t>
                      </a:r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8303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AAAGAATTTGCTGCAAAGA</a:t>
                      </a:r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13538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CAATTCACTTTGTACTGTTT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L044-C1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-t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GTGACCAAGTTCATGCTCTGCCTGTTACTTGTGTTGATG</a:t>
                      </a:r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93345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CCTGTTACTTGTGTTGATG</a:t>
                      </a:r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56388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CCTTGAACCAAGAAAGCA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L023-T-7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-t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GTGACCAAGTTCATGCTTGCCAATAGAACCAGGTGTATC</a:t>
                      </a:r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45923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CAATAGAACCAGGTGTATC</a:t>
                      </a:r>
                      <a:r>
                        <a:rPr lang="en-US" sz="900" b="1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ATTGGAGAGCTGCACGTAAT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L048-T4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-t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GTGACCAAGTTCATGCTCTTGAGCTCCACCTCACACTTC</a:t>
                      </a:r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37541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TGAGCTCCACCTCACACTTC</a:t>
                      </a:r>
                      <a:r>
                        <a:rPr lang="en-US" sz="9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TGCTCCTTTAACCGTTGAC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49824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31</TotalTime>
  <Words>322</Words>
  <Application>Microsoft Office PowerPoint</Application>
  <PresentationFormat>On-screen Show (4:3)</PresentationFormat>
  <Paragraphs>10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AMU Soil &amp; Crop Sciences Dept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ngbin Zhang</dc:creator>
  <cp:lastModifiedBy>Zhang, Hongbin</cp:lastModifiedBy>
  <cp:revision>50</cp:revision>
  <cp:lastPrinted>2016-08-29T15:50:24Z</cp:lastPrinted>
  <dcterms:created xsi:type="dcterms:W3CDTF">2016-08-27T23:41:37Z</dcterms:created>
  <dcterms:modified xsi:type="dcterms:W3CDTF">2020-07-13T17:04:25Z</dcterms:modified>
</cp:coreProperties>
</file>